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10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media/image9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57A34-3EEC-4336-86F0-A755C03DAF7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4C3E5-F6A8-47D1-ACF3-1CCC1E7F2E0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DAD294-8587-4BC0-9C9D-2DADC5D80B1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3556C5-C2F0-49AE-B820-027E21C266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07DA09-5838-4DD3-BF30-3D09915FA9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45FA8-C495-43B6-A100-3202C0A429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66EA1D-F52C-4626-A36D-4E461AB12E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15DF1E-E941-43E6-9B03-AC5D409E19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18B509-2CC9-4351-A8C9-135814DC06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8ACAE7-763E-42E1-BDFE-19A61AED1D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94D958-93DB-44EC-B653-2A2176EFED9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67179-BF45-4F10-8722-D9CAB217B5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2AF3AB9-5892-48A6-9C8A-F777D8F71836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8.wmf"/><Relationship Id="rId3" Type="http://schemas.openxmlformats.org/officeDocument/2006/relationships/image" Target="../media/image9.wmf"/><Relationship Id="rId4" Type="http://schemas.openxmlformats.org/officeDocument/2006/relationships/image" Target="../media/image10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0"/>
          <a:ext cx="6813720" cy="8342280"/>
        </p:xfrm>
        <a:graphic>
          <a:graphicData uri="http://schemas.openxmlformats.org/drawingml/2006/table">
            <a:tbl>
              <a:tblPr/>
              <a:tblGrid>
                <a:gridCol w="836640"/>
                <a:gridCol w="1297080"/>
                <a:gridCol w="1655640"/>
                <a:gridCol w="719280"/>
                <a:gridCol w="720720"/>
                <a:gridCol w="1584360"/>
              </a:tblGrid>
              <a:tr h="83520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pot No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ccession No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Fol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hang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p- 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   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Relative spot intens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576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64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16178380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polipoprote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B-100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ecursor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4.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3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576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1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MPO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minopeptidase  o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9176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00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PIB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erine /threonine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hosphate pp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beta catalytic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ubunit 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576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77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Gi|30039019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 kinase ancho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 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1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63404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31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LPPRC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Leucine-rich PP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otif-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ontaining protein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5576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618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YDC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spartate-tRNA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lig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3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pic>
        <p:nvPicPr>
          <p:cNvPr id="42" name="Picture 11" descr=""/>
          <p:cNvPicPr/>
          <p:nvPr/>
        </p:nvPicPr>
        <p:blipFill>
          <a:blip r:embed="rId1"/>
          <a:srcRect l="26305" t="42475" r="0" b="8024"/>
          <a:stretch/>
        </p:blipFill>
        <p:spPr>
          <a:xfrm>
            <a:off x="5419800" y="2735280"/>
            <a:ext cx="1379520" cy="5000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9" descr=""/>
          <p:cNvPicPr/>
          <p:nvPr/>
        </p:nvPicPr>
        <p:blipFill>
          <a:blip r:embed="rId2"/>
          <a:srcRect l="60879" t="54643" r="0" b="0"/>
          <a:stretch/>
        </p:blipFill>
        <p:spPr>
          <a:xfrm>
            <a:off x="5326200" y="3851280"/>
            <a:ext cx="1379520" cy="6523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8" descr=""/>
          <p:cNvPicPr/>
          <p:nvPr/>
        </p:nvPicPr>
        <p:blipFill>
          <a:blip r:embed="rId3"/>
          <a:srcRect l="48134" t="63138" r="21875" b="7008"/>
          <a:stretch/>
        </p:blipFill>
        <p:spPr>
          <a:xfrm>
            <a:off x="5288040" y="7763040"/>
            <a:ext cx="1368360" cy="64260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3" descr=""/>
          <p:cNvPicPr/>
          <p:nvPr/>
        </p:nvPicPr>
        <p:blipFill>
          <a:blip r:embed="rId4"/>
          <a:stretch/>
        </p:blipFill>
        <p:spPr>
          <a:xfrm>
            <a:off x="5173560" y="6048360"/>
            <a:ext cx="1640160" cy="1076400"/>
          </a:xfrm>
          <a:prstGeom prst="rect">
            <a:avLst/>
          </a:prstGeom>
          <a:ln w="0">
            <a:noFill/>
          </a:ln>
        </p:spPr>
      </p:pic>
      <p:pic>
        <p:nvPicPr>
          <p:cNvPr id="46" name="Picture 2" descr=""/>
          <p:cNvPicPr/>
          <p:nvPr/>
        </p:nvPicPr>
        <p:blipFill>
          <a:blip r:embed="rId5"/>
          <a:srcRect l="31540" t="43496" r="9365" b="0"/>
          <a:stretch/>
        </p:blipFill>
        <p:spPr>
          <a:xfrm>
            <a:off x="5303880" y="5075280"/>
            <a:ext cx="1353960" cy="669960"/>
          </a:xfrm>
          <a:prstGeom prst="rect">
            <a:avLst/>
          </a:prstGeom>
          <a:ln w="0">
            <a:noFill/>
          </a:ln>
        </p:spPr>
      </p:pic>
      <p:pic>
        <p:nvPicPr>
          <p:cNvPr id="47" name="Picture 3" descr=""/>
          <p:cNvPicPr/>
          <p:nvPr/>
        </p:nvPicPr>
        <p:blipFill>
          <a:blip r:embed="rId6"/>
          <a:srcRect l="0" t="43549" r="18978" b="0"/>
          <a:stretch/>
        </p:blipFill>
        <p:spPr>
          <a:xfrm>
            <a:off x="5275440" y="1355760"/>
            <a:ext cx="1357200" cy="689040"/>
          </a:xfrm>
          <a:prstGeom prst="rect">
            <a:avLst/>
          </a:prstGeom>
          <a:ln w="0">
            <a:noFill/>
          </a:ln>
        </p:spPr>
      </p:pic>
      <p:sp>
        <p:nvSpPr>
          <p:cNvPr id="48" name="TextBox 14"/>
          <p:cNvSpPr/>
          <p:nvPr/>
        </p:nvSpPr>
        <p:spPr>
          <a:xfrm>
            <a:off x="5321160" y="503280"/>
            <a:ext cx="142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CNT    6 h    12 h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9" name=""/>
          <p:cNvGraphicFramePr/>
          <p:nvPr/>
        </p:nvGraphicFramePr>
        <p:xfrm>
          <a:off x="69840" y="144360"/>
          <a:ext cx="6813720" cy="5745240"/>
        </p:xfrm>
        <a:graphic>
          <a:graphicData uri="http://schemas.openxmlformats.org/drawingml/2006/table">
            <a:tbl>
              <a:tblPr/>
              <a:tblGrid>
                <a:gridCol w="928800"/>
                <a:gridCol w="1279440"/>
                <a:gridCol w="1584360"/>
                <a:gridCol w="718920"/>
                <a:gridCol w="648000"/>
                <a:gridCol w="1654200"/>
              </a:tblGrid>
              <a:tr h="83844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Spot No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ccession No: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Protein nam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Fol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hang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p- valu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    </a:t>
                      </a: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Relative spot intensity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2544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266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KO3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mitoge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ctivated protein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kinase 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1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2724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65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XIRP2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Xin actin –binding repeat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containing protein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3.9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0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2688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840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DT2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ADP/ATP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Translocase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1.7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5.721e-00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227240"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04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EF2K_RA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Eukaryotic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elongation factor 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kin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</a:rPr>
                        <a:t>2.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맑은 고딕"/>
                          <a:ea typeface="맑은 고딕"/>
                        </a:rPr>
                        <a:t>0.034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24120" rIns="2412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굴림"/>
                      </a:endParaRPr>
                    </a:p>
                  </a:txBody>
                  <a:tcPr anchor="ctr" marL="24120" marR="2412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0" name="TextBox 4"/>
          <p:cNvSpPr/>
          <p:nvPr/>
        </p:nvSpPr>
        <p:spPr>
          <a:xfrm>
            <a:off x="5288040" y="779400"/>
            <a:ext cx="14288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CNT    6 h    12 h </a:t>
            </a:r>
            <a:endParaRPr b="0" lang="en-US" sz="1100" spc="-1" strike="noStrike">
              <a:solidFill>
                <a:srgbClr val="000000"/>
              </a:solidFill>
              <a:latin typeface="굴림"/>
            </a:endParaRPr>
          </a:p>
        </p:txBody>
      </p:sp>
      <p:pic>
        <p:nvPicPr>
          <p:cNvPr id="51" name="Picture 6" descr=""/>
          <p:cNvPicPr/>
          <p:nvPr/>
        </p:nvPicPr>
        <p:blipFill>
          <a:blip r:embed="rId1"/>
          <a:srcRect l="74150" t="77963" r="0" b="0"/>
          <a:stretch/>
        </p:blipFill>
        <p:spPr>
          <a:xfrm>
            <a:off x="5308560" y="4154400"/>
            <a:ext cx="1397160" cy="6177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5" descr=""/>
          <p:cNvPicPr/>
          <p:nvPr/>
        </p:nvPicPr>
        <p:blipFill>
          <a:blip r:embed="rId2"/>
          <a:srcRect l="74957" t="75146" r="0" b="0"/>
          <a:stretch/>
        </p:blipFill>
        <p:spPr>
          <a:xfrm>
            <a:off x="5326200" y="5308560"/>
            <a:ext cx="1396800" cy="7034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7" descr=""/>
          <p:cNvPicPr/>
          <p:nvPr/>
        </p:nvPicPr>
        <p:blipFill>
          <a:blip r:embed="rId3"/>
          <a:srcRect l="63936" t="68223" r="0" b="0"/>
          <a:stretch/>
        </p:blipFill>
        <p:spPr>
          <a:xfrm>
            <a:off x="5343480" y="2922480"/>
            <a:ext cx="1346400" cy="6177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2" descr=""/>
          <p:cNvPicPr/>
          <p:nvPr/>
        </p:nvPicPr>
        <p:blipFill>
          <a:blip r:embed="rId4"/>
          <a:stretch/>
        </p:blipFill>
        <p:spPr>
          <a:xfrm>
            <a:off x="5272200" y="1319040"/>
            <a:ext cx="1428480" cy="920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1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5-12T14:30:15Z</dcterms:created>
  <dc:creator>1</dc:creator>
  <dc:description/>
  <dc:language>en-US</dc:language>
  <cp:lastModifiedBy>USER</cp:lastModifiedBy>
  <dcterms:modified xsi:type="dcterms:W3CDTF">2015-04-29T14:04:43Z</dcterms:modified>
  <cp:revision>16</cp:revision>
  <dc:subject/>
  <dc:title>슬라이드 1</dc:title>
</cp:coreProperties>
</file>